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82907" autoAdjust="0"/>
  </p:normalViewPr>
  <p:slideViewPr>
    <p:cSldViewPr snapToGrid="0">
      <p:cViewPr varScale="1">
        <p:scale>
          <a:sx n="84" d="100"/>
          <a:sy n="84" d="100"/>
        </p:scale>
        <p:origin x="15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5DACF7-C698-4D4D-8FE0-0B09687B00CD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BBE36F-AA90-410E-9181-2C399E46623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47509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Helvetica" panose="020B0604020202020204" pitchFamily="34" charset="0"/>
              </a:rPr>
              <a:t>Supplementary Figure 1</a:t>
            </a:r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BBE36F-AA90-410E-9181-2C399E46623F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397751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62F34E8-7EF9-4877-A2AB-A219C0554F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B9352CB1-1787-4945-AED0-FB07C05425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1C67292-2205-4D0B-9AE4-DE5FA9821F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D9C6E-1904-42C6-9106-1DA737290499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38AD645-69BB-426D-A718-371CC95B53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E180104-A134-4BE1-875B-D755A76F8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EBD13-2389-4DEF-BCE2-BAB178ACF9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1009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D2FCBFD-498B-461C-B519-6D5FE91FC8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CAF344A-C3EC-48BE-B2A6-6E7080308B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27BB82F-9D7A-4E90-B2D1-87066E8A2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D9C6E-1904-42C6-9106-1DA737290499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3A4B4BF-D9F3-4E2F-868D-F29C483656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856D590-CB3B-4D79-8862-81F937085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EBD13-2389-4DEF-BCE2-BAB178ACF9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4421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7A9FA1EE-3891-402C-9094-2A77654343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2999324-EB1D-48C6-AD02-6AC010486D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BCF1731-A4F0-4844-8218-37908394B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D9C6E-1904-42C6-9106-1DA737290499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F327A65-5626-439D-81A9-AD775F100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8A7534A-4A6C-4306-92AA-27D2114809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EBD13-2389-4DEF-BCE2-BAB178ACF9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59436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65ADEE8-E4B8-49A6-AEC5-67FC089A8B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303F7EB-5CD2-46A9-83E3-E9DFFB43777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97DD3DF-0D20-4951-BD20-B18544BC94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D9C6E-1904-42C6-9106-1DA737290499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806A2F2-2071-4C38-A15F-B6F4E2C17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19C5299-D3B6-49F8-8043-2E79F28B2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EBD13-2389-4DEF-BCE2-BAB178ACF9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6505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C2392BB-16E7-4B58-9698-004FA68191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BA8E6BF-0CD0-48C3-BCB7-748CF9A6C3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774E88A-BFEA-410A-B4D7-6D39D086A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D9C6E-1904-42C6-9106-1DA737290499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0CD7161-D8F6-4682-ACDF-68C7E3D033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2CE5382-C108-4848-91F4-A66BE63FF5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EBD13-2389-4DEF-BCE2-BAB178ACF9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98540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BAE02FE-59AC-4FC0-A70B-57B16E3D41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23E3FF4-6EE6-4288-98B5-6409DFCC70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CF78FF7-7454-4051-B970-E00CA4D84B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91D82CF-A5BB-4A2B-8587-0278292A8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D9C6E-1904-42C6-9106-1DA737290499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6B9FB8-F37D-421C-950A-2EA0AE5A11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722C246-A67A-461E-ACDE-34A968EB5F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EBD13-2389-4DEF-BCE2-BAB178ACF9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8549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F3754E7-07B1-4B0F-BA27-22B1896E37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1CADA98-8674-4857-9BAB-7D6B0FA92D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9CF2505-E9D6-437C-9C6B-EE922C6CB9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FBD47929-6686-4045-8DF2-9313029702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5DADC4A6-BF44-4B85-8110-63DE09E371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62BCA6D7-E962-4658-8AA6-110458C2D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D9C6E-1904-42C6-9106-1DA737290499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E1075D46-981A-45F1-98E7-9CC81CD19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B07304A-5058-4A46-B1B3-0D3E66E615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EBD13-2389-4DEF-BCE2-BAB178ACF9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8338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2A1BFED-AFAC-4841-AE54-B06D2AEB5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D456085-564D-4018-88DE-35DBAD623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D9C6E-1904-42C6-9106-1DA737290499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B4E3EAB-93EE-4519-97AF-DED8AF427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23ECA0D-313A-4EAD-BAB4-A78FF1550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EBD13-2389-4DEF-BCE2-BAB178ACF9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93338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A529BF0-2E52-43F1-B54E-FCF5FCD93B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D9C6E-1904-42C6-9106-1DA737290499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BB5AD6E7-A54E-4978-B6FB-3342647E99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35C71AFE-FA0E-46B9-9772-80F7254AE0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EBD13-2389-4DEF-BCE2-BAB178ACF9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8948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820B6B-9ACC-4C70-B364-86AC222853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0464963-B3E5-455A-9B24-DDFDC3E4F9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15645C8-EDC2-453E-B5DD-438E4B6DC0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60B49B5-B0CB-4B1D-ADA9-16CC9ED212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D9C6E-1904-42C6-9106-1DA737290499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63DF951-CABB-449B-851D-2DC5AE7D4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AA51F5CC-B043-4DA2-8A81-14779741C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EBD13-2389-4DEF-BCE2-BAB178ACF9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3273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6246466-05A9-40BF-9BEB-A1D1311197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50B37D6-19E7-4932-A769-5DA88B8EA0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842F37D-33DF-4F94-8F70-93846B8FF8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04E02D41-8DA8-448C-9EB4-899371EC2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9D9C6E-1904-42C6-9106-1DA737290499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455FA45-FE72-43CA-A2F4-252BB7F16C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A0A4FF4-5772-4364-A655-A309F85BB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4EBD13-2389-4DEF-BCE2-BAB178ACF9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71347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7C47DBDE-46EB-4632-8872-63DDDDFBDC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CAAF38A-30B2-49F3-B07C-AB4603F18B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ED638EF-2493-48BE-9735-9318D627CD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9D9C6E-1904-42C6-9106-1DA737290499}" type="datetimeFigureOut">
              <a:rPr lang="fr-FR" smtClean="0"/>
              <a:t>23/04/2025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5E2C911-C98E-4BEE-BBEC-7347E17802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DFF6FE3-6492-4733-AC38-7FC627F085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4EBD13-2389-4DEF-BCE2-BAB178ACF9E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2351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>
            <a:extLst>
              <a:ext uri="{FF2B5EF4-FFF2-40B4-BE49-F238E27FC236}">
                <a16:creationId xmlns:a16="http://schemas.microsoft.com/office/drawing/2014/main" id="{C10927CA-F10A-4551-C6FB-B789BD014E61}"/>
              </a:ext>
            </a:extLst>
          </p:cNvPr>
          <p:cNvGrpSpPr/>
          <p:nvPr/>
        </p:nvGrpSpPr>
        <p:grpSpPr>
          <a:xfrm>
            <a:off x="-31185" y="1348431"/>
            <a:ext cx="12192705" cy="3886818"/>
            <a:chOff x="-22087" y="527504"/>
            <a:chExt cx="12192705" cy="3886818"/>
          </a:xfrm>
        </p:grpSpPr>
        <p:sp>
          <p:nvSpPr>
            <p:cNvPr id="223" name="Rectangle 222">
              <a:extLst>
                <a:ext uri="{FF2B5EF4-FFF2-40B4-BE49-F238E27FC236}">
                  <a16:creationId xmlns:a16="http://schemas.microsoft.com/office/drawing/2014/main" id="{7D057772-7BCB-4F07-B351-59395D164956}"/>
                </a:ext>
              </a:extLst>
            </p:cNvPr>
            <p:cNvSpPr/>
            <p:nvPr/>
          </p:nvSpPr>
          <p:spPr>
            <a:xfrm>
              <a:off x="516704" y="535403"/>
              <a:ext cx="313419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After P-IMCU, N-IMCU, C-IMCU or ICU admission</a:t>
              </a:r>
              <a:endParaRPr lang="fr-FR" sz="1000" dirty="0"/>
            </a:p>
          </p:txBody>
        </p:sp>
        <p:sp>
          <p:nvSpPr>
            <p:cNvPr id="224" name="Rectangle 223">
              <a:extLst>
                <a:ext uri="{FF2B5EF4-FFF2-40B4-BE49-F238E27FC236}">
                  <a16:creationId xmlns:a16="http://schemas.microsoft.com/office/drawing/2014/main" id="{AE007E25-FF63-4ACF-A3C5-C7F8CBE30B7D}"/>
                </a:ext>
              </a:extLst>
            </p:cNvPr>
            <p:cNvSpPr/>
            <p:nvPr/>
          </p:nvSpPr>
          <p:spPr>
            <a:xfrm>
              <a:off x="4694748" y="527505"/>
              <a:ext cx="310533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After </a:t>
              </a:r>
              <a:r>
                <a:rPr lang="en-US" sz="1000" b="1" dirty="0">
                  <a:solidFill>
                    <a:srgbClr val="000000"/>
                  </a:solidFill>
                  <a:latin typeface="Helvetica" panose="020B0604020202020204" pitchFamily="34" charset="0"/>
                  <a:ea typeface="Times New Roman" panose="02020603050405020304" pitchFamily="18" charset="0"/>
                  <a:cs typeface="Helvetica" panose="020B0604020202020204" pitchFamily="34" charset="0"/>
                </a:rPr>
                <a:t>P-IMCU, N-IMCU, C-IMCU or ICU </a:t>
              </a:r>
              <a:r>
                <a:rPr lang="en-US" sz="1000" b="1" dirty="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discharge</a:t>
              </a:r>
              <a:endParaRPr lang="fr-FR" sz="1000" b="1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225" name="Rectangle 224">
              <a:extLst>
                <a:ext uri="{FF2B5EF4-FFF2-40B4-BE49-F238E27FC236}">
                  <a16:creationId xmlns:a16="http://schemas.microsoft.com/office/drawing/2014/main" id="{09BD6972-9FA1-4ED2-9810-2B7635D645A2}"/>
                </a:ext>
              </a:extLst>
            </p:cNvPr>
            <p:cNvSpPr/>
            <p:nvPr/>
          </p:nvSpPr>
          <p:spPr>
            <a:xfrm>
              <a:off x="9543522" y="527504"/>
              <a:ext cx="164820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b="1" dirty="0">
                  <a:solidFill>
                    <a:srgbClr val="000000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After hospital discharge</a:t>
              </a:r>
              <a:endParaRPr lang="fr-FR" sz="1000" b="1" dirty="0">
                <a:solidFill>
                  <a:srgbClr val="000000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pic>
          <p:nvPicPr>
            <p:cNvPr id="2" name="Image 1">
              <a:extLst>
                <a:ext uri="{FF2B5EF4-FFF2-40B4-BE49-F238E27FC236}">
                  <a16:creationId xmlns:a16="http://schemas.microsoft.com/office/drawing/2014/main" id="{A21FBAFA-9C03-428D-AB0E-21F95509097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22087" y="792370"/>
              <a:ext cx="4140000" cy="3584473"/>
            </a:xfrm>
            <a:prstGeom prst="rect">
              <a:avLst/>
            </a:prstGeom>
          </p:spPr>
        </p:pic>
        <p:pic>
          <p:nvPicPr>
            <p:cNvPr id="4" name="Image 3">
              <a:extLst>
                <a:ext uri="{FF2B5EF4-FFF2-40B4-BE49-F238E27FC236}">
                  <a16:creationId xmlns:a16="http://schemas.microsoft.com/office/drawing/2014/main" id="{F6395804-E7E0-4EA1-8590-0970545DD1A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210618" y="806955"/>
              <a:ext cx="3960000" cy="3555144"/>
            </a:xfrm>
            <a:prstGeom prst="rect">
              <a:avLst/>
            </a:prstGeom>
          </p:spPr>
        </p:pic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D53006AA-8F66-40F4-AF4D-485B24B89FC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070618" y="697581"/>
              <a:ext cx="4140000" cy="371674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46044479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25</Words>
  <Application>Microsoft Macintosh PowerPoint</Application>
  <PresentationFormat>Grand écran</PresentationFormat>
  <Paragraphs>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toine Guillon</dc:creator>
  <cp:lastModifiedBy>Adrien Migeon</cp:lastModifiedBy>
  <cp:revision>20</cp:revision>
  <dcterms:created xsi:type="dcterms:W3CDTF">2025-01-03T13:40:12Z</dcterms:created>
  <dcterms:modified xsi:type="dcterms:W3CDTF">2025-04-23T18:42:39Z</dcterms:modified>
</cp:coreProperties>
</file>